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85170" autoAdjust="0"/>
  </p:normalViewPr>
  <p:slideViewPr>
    <p:cSldViewPr snapToGrid="0">
      <p:cViewPr varScale="1">
        <p:scale>
          <a:sx n="49" d="100"/>
          <a:sy n="49" d="100"/>
        </p:scale>
        <p:origin x="251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2D819-0776-157B-A90B-35398B50F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04" y="201139"/>
            <a:ext cx="6668608" cy="416344"/>
          </a:xfrm>
        </p:spPr>
        <p:txBody>
          <a:bodyPr>
            <a:no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Flow cytometry of immune cells from serially collected blood samples with evidence of significant decrease in circulating NK cells in: A) Metastatic renal cell carcinoma cohort. B) MIBC cohort.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38FCE08-F8E1-F48C-F443-44FFFDCAD4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62" y="3046656"/>
            <a:ext cx="1716743" cy="15059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168C4A5-5112-B90A-AC2B-422DB412C2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4455" y="3069927"/>
            <a:ext cx="1716743" cy="150591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89048F9-5F02-37D6-3A11-9B2008CDB5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3419" y="3023517"/>
            <a:ext cx="1783144" cy="15641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3256549-078D-4A16-248A-601D9DA77D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53468" y="3010290"/>
            <a:ext cx="1757662" cy="157738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18F7FEF-878B-BCDB-589D-6A58FBF5EF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04455" y="1217140"/>
            <a:ext cx="1716743" cy="15021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20F2F36-8A93-5323-FBCA-1409E693842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18886" y="1201004"/>
            <a:ext cx="1766065" cy="154530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C6A3E33-4ED5-121E-792A-3BA7AA611E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53468" y="1177795"/>
            <a:ext cx="1809870" cy="1583637"/>
          </a:xfrm>
          <a:prstGeom prst="rect">
            <a:avLst/>
          </a:prstGeom>
          <a:ln w="28575">
            <a:noFill/>
          </a:ln>
        </p:spPr>
      </p:pic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90C652B3-A6C2-47D7-C059-2DC51EB38B2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9"/>
          <a:stretch>
            <a:fillRect/>
          </a:stretch>
        </p:blipFill>
        <p:spPr>
          <a:xfrm>
            <a:off x="94662" y="1167251"/>
            <a:ext cx="1716743" cy="154463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1EF2A5A-63AF-8FF5-C55D-FD8F00B60DE5}"/>
              </a:ext>
            </a:extLst>
          </p:cNvPr>
          <p:cNvSpPr txBox="1"/>
          <p:nvPr/>
        </p:nvSpPr>
        <p:spPr>
          <a:xfrm>
            <a:off x="0" y="7206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49C1E24-B85B-0D3A-CC76-C92BFAEA5A5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13178"/>
          <a:stretch/>
        </p:blipFill>
        <p:spPr>
          <a:xfrm>
            <a:off x="158858" y="5484246"/>
            <a:ext cx="1512961" cy="157290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6E60CC8-FBC4-F689-6B70-11566F3A647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04455" y="5559301"/>
            <a:ext cx="1747553" cy="150591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6CA63A2-16B5-2B80-4B5B-D9B58B6CB4F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18886" y="5570479"/>
            <a:ext cx="1734582" cy="149473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B7AB5027-FC6E-936F-E06A-A58E2BF749C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84951" y="5568866"/>
            <a:ext cx="1678491" cy="1486786"/>
          </a:xfrm>
          <a:prstGeom prst="rect">
            <a:avLst/>
          </a:prstGeom>
          <a:ln w="28575">
            <a:noFill/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A3E6594-0B12-D734-02F7-412859B8E0D0}"/>
              </a:ext>
            </a:extLst>
          </p:cNvPr>
          <p:cNvSpPr txBox="1"/>
          <p:nvPr/>
        </p:nvSpPr>
        <p:spPr>
          <a:xfrm>
            <a:off x="11582" y="48238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57E35202-05A6-FAFA-7B99-F11B664E675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9036" y="7282791"/>
            <a:ext cx="1653306" cy="1446124"/>
          </a:xfrm>
          <a:prstGeom prst="rect">
            <a:avLst/>
          </a:prstGeom>
          <a:ln w="28575"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DC84B9D-D655-BF9E-D02C-43D8AC4011B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681447" y="7244932"/>
            <a:ext cx="1747553" cy="150964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5B18A3D-96A0-BB03-1F33-A4A78BB589E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45145" y="7205688"/>
            <a:ext cx="1781418" cy="154330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C5D048A-B9C6-A21D-C6D2-CFB1053DF7C8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993051" y="7226531"/>
            <a:ext cx="1747553" cy="1547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7818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44</TotalTime>
  <Words>40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4: Flow cytometry of immune cells from serially collected blood samples with evidence of significant decrease in circulating NK cells in: A) Metastatic renal cell carcinoma cohort. B) MIBC cohort.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4</cp:revision>
  <dcterms:created xsi:type="dcterms:W3CDTF">2023-03-30T22:39:16Z</dcterms:created>
  <dcterms:modified xsi:type="dcterms:W3CDTF">2024-06-26T14:34:02Z</dcterms:modified>
</cp:coreProperties>
</file>